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  <p:sldId id="257" r:id="rId3"/>
    <p:sldId id="258" r:id="rId4"/>
    <p:sldId id="256" r:id="rId5"/>
    <p:sldId id="259" r:id="rId6"/>
    <p:sldId id="263" r:id="rId7"/>
    <p:sldId id="264" r:id="rId8"/>
    <p:sldId id="262" r:id="rId9"/>
    <p:sldId id="260" r:id="rId10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Stile chi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B4B98B0-60AC-42C2-AFA5-B58CD77FA1E5}" styleName="Stile chiaro 1 - Color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D27102A9-8310-4765-A935-A1911B00CA55}" styleName="Stile chiaro 1 - Colore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5FD0F851-EC5A-4D38-B0AD-8093EC10F338}" styleName="Stile chiaro 1 - Colore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703"/>
    <p:restoredTop sz="94595"/>
  </p:normalViewPr>
  <p:slideViewPr>
    <p:cSldViewPr snapToGrid="0">
      <p:cViewPr varScale="1">
        <p:scale>
          <a:sx n="75" d="100"/>
          <a:sy n="75" d="100"/>
        </p:scale>
        <p:origin x="160" y="7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DB02231-397E-A5E4-CC40-0B65EC03E0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B477D2CB-0F7B-2817-6306-8224F014EE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03824F8-1436-8AB9-4EE8-6912BCAD99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71669-2CCD-364A-A013-D836436CAF98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C0B4E8B-B3D7-B896-E846-E57A4F5AF2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5772D99-19DE-F169-8992-4169F9FE0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4B6D2-70BF-9845-8C7A-A874E209A33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4627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2A9C145-D210-0CF5-5803-25E91572C9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938FCF4-722B-62C4-3A14-896127B9A7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12F3AB3-4B0E-1E56-B430-08AC5E6E00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71669-2CCD-364A-A013-D836436CAF98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61D7A48-087F-818F-1686-E2818258F3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06C0D12-5FBF-C952-931C-98B5F4E6B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4B6D2-70BF-9845-8C7A-A874E209A33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6505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EB2067AC-AF68-9CF3-6170-27D82AA1B1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D7B6861-FCF3-2AC4-29E2-2E30FE1B60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EED7800-02CF-3288-F674-7EB9AA9D1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71669-2CCD-364A-A013-D836436CAF98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CB73251-41B6-B2D9-04F2-9C51EFC069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DB2DAFF-702F-2387-4EF1-A5B3C5FFEC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4B6D2-70BF-9845-8C7A-A874E209A33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968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E4C283F-0E10-51BF-0956-10A69A1478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573C2EC-B6CB-18C5-3433-ABC1A0DA61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A60FD5D-BCA6-BBE7-3E88-B2B694472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71669-2CCD-364A-A013-D836436CAF98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1239FE7-C9F0-3D06-43E8-CFB1767EA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C6B4200-1C58-8570-C33F-EFB1B47197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4B6D2-70BF-9845-8C7A-A874E209A33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87959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ECEE852-E124-A079-8F63-C1E15DE620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FBFABB6-15AB-AB11-5F03-2C3A5BBAE2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A5FBFE5-D27E-AB3E-9F0B-F062DA2CFD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71669-2CCD-364A-A013-D836436CAF98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EB13CFB-711F-E2BA-5DE1-4F3D81862A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B825C41-EFE0-9C29-D639-8441AC4B4A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4B6D2-70BF-9845-8C7A-A874E209A33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14474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E019BE9-60EC-AAE9-3D28-A228B94682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51ECDA8-DD42-1E67-85CF-C0669933D9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68BBC47-670C-D38D-8FE4-BF18804763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B9F5EC2-0068-2307-F8B2-A5CA5A4AAB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71669-2CCD-364A-A013-D836436CAF98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3DF1A15-9ED4-EA17-4389-7B9E3BAF62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1E3AD21-FE18-4DAA-4596-907C18BFEB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4B6D2-70BF-9845-8C7A-A874E209A33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5340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3B8A077-1A53-1619-FD1A-BB3248EF71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28045F3-AAB5-AE8B-3C3B-80681FB97E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C77C6D6-CEA6-E07B-F8CB-0B424089D1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8238E214-1983-6FE6-FBCE-5EF363FD25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93CD13F0-6168-1F65-979E-06FE025997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3F2E9ED9-6803-A3FE-2BC4-EA7F030F2A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71669-2CCD-364A-A013-D836436CAF98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FEABF71E-C6C8-213B-2A8D-5E52DC8D98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9248F7E1-0F49-D36A-3944-80EFFF4FE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4B6D2-70BF-9845-8C7A-A874E209A33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2956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2B0C1F8-019C-828D-ED7F-DA3094F7DF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8ECF034-513A-F91E-FE1C-D27B9D6FC7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71669-2CCD-364A-A013-D836436CAF98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0491AF43-5B79-EDA8-07DF-D78632C6CD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E8BBFA77-435B-68AD-C8FB-71A56A433D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4B6D2-70BF-9845-8C7A-A874E209A33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99483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9758BD09-2A12-3337-6591-A8137AB218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71669-2CCD-364A-A013-D836436CAF98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9E0DC9ED-FA0F-111D-F439-F98AD623B2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5A2D5CC8-E869-FD0B-D491-3717B0CB65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4B6D2-70BF-9845-8C7A-A874E209A33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06667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40FE288-DD40-6982-24EC-567E763F49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E292B5F-FD3C-EBA3-B46D-BD463F0396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7E7163F-B946-B07F-5DB4-F061A45DC9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FCF5237-A16A-4D3E-4A48-45FC60B944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71669-2CCD-364A-A013-D836436CAF98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5DF98C9-4E6A-D606-8036-FB5163C3BD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42E39D6-6FBB-57FA-0B56-9B3AB36D3D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4B6D2-70BF-9845-8C7A-A874E209A33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770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F474850-B28B-C235-F74B-2541E7F096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928DB584-379A-DA9F-80B4-5F1390B8D5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2ADF973-6453-7E4E-E1D0-67D4763605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223BB50-1851-96C4-7A1A-499A2E08D4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71669-2CCD-364A-A013-D836436CAF98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7E46657-9391-3570-1677-8C3F2B6FAD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51E9915-0CBB-43F5-D2FA-069FB32A2B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4B6D2-70BF-9845-8C7A-A874E209A33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69236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DFA20B75-DAE5-C2AC-EBCF-710C2B5F97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DE83B30-00E4-02F3-86BB-5016260507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DCA3602-DA09-73C2-D5FB-C354F754FE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B971669-2CCD-364A-A013-D836436CAF98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7E857DC-A82E-E24E-EA5E-254D565182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C98C8BF-0CC4-5DC7-C55B-6228BB7DA4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44B6D2-70BF-9845-8C7A-A874E209A33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5006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E850270-A827-B64B-8C86-F61CCF3033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1) 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Cochrane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risk-of-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bias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tool for 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randomized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trials (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RoB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2)</a:t>
            </a:r>
            <a:endParaRPr lang="en-GB" dirty="0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1E37423-B5FA-8374-C008-8614A54A79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Per Protocols study (Summary Table)</a:t>
            </a:r>
          </a:p>
          <a:p>
            <a:r>
              <a:rPr lang="en-GB" dirty="0"/>
              <a:t>Per Protocols study (Figure Output)</a:t>
            </a:r>
          </a:p>
          <a:p>
            <a:r>
              <a:rPr lang="en-GB" dirty="0"/>
              <a:t>Intention to treat study (Summary Table)</a:t>
            </a:r>
          </a:p>
          <a:p>
            <a:r>
              <a:rPr lang="en-GB" dirty="0"/>
              <a:t>Intention to treat study (Figure Output)</a:t>
            </a:r>
          </a:p>
        </p:txBody>
      </p:sp>
    </p:spTree>
    <p:extLst>
      <p:ext uri="{BB962C8B-B14F-4D97-AF65-F5344CB8AC3E}">
        <p14:creationId xmlns:p14="http://schemas.microsoft.com/office/powerpoint/2010/main" val="24599619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EE678176-494B-374E-7D49-46F81DD76D87}"/>
              </a:ext>
            </a:extLst>
          </p:cNvPr>
          <p:cNvSpPr txBox="1"/>
          <p:nvPr/>
        </p:nvSpPr>
        <p:spPr>
          <a:xfrm>
            <a:off x="744792" y="643711"/>
            <a:ext cx="90781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Suppl. Figure 1: 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Cochrane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risk-of-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bias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tool for 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randomized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trials (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RoB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2) </a:t>
            </a:r>
            <a:r>
              <a:rPr lang="en-GB" dirty="0">
                <a:solidFill>
                  <a:srgbClr val="333333"/>
                </a:solidFill>
                <a:latin typeface="Source Sans Pro" panose="020B0503030403020204" pitchFamily="34" charset="0"/>
              </a:rPr>
              <a:t>- Per Protocol studies</a:t>
            </a:r>
            <a:endParaRPr lang="en-GB" dirty="0"/>
          </a:p>
        </p:txBody>
      </p:sp>
      <p:pic>
        <p:nvPicPr>
          <p:cNvPr id="3" name="Immagine 2" descr="Immagine che contiene testo, schermata, Carattere, linea&#10;&#10;Descrizione generata automaticamente">
            <a:extLst>
              <a:ext uri="{FF2B5EF4-FFF2-40B4-BE49-F238E27FC236}">
                <a16:creationId xmlns:a16="http://schemas.microsoft.com/office/drawing/2014/main" id="{A1592E98-33C8-71D1-5992-7D2F8E6B14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4792" y="1255102"/>
            <a:ext cx="9078125" cy="4347796"/>
          </a:xfrm>
          <a:prstGeom prst="rect">
            <a:avLst/>
          </a:prstGeom>
          <a:ln w="12700">
            <a:noFill/>
          </a:ln>
        </p:spPr>
      </p:pic>
    </p:spTree>
    <p:extLst>
      <p:ext uri="{BB962C8B-B14F-4D97-AF65-F5344CB8AC3E}">
        <p14:creationId xmlns:p14="http://schemas.microsoft.com/office/powerpoint/2010/main" val="32871017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B3EFE022-764D-C202-942F-97B38BD889A7}"/>
              </a:ext>
            </a:extLst>
          </p:cNvPr>
          <p:cNvSpPr txBox="1"/>
          <p:nvPr/>
        </p:nvSpPr>
        <p:spPr>
          <a:xfrm>
            <a:off x="730504" y="829062"/>
            <a:ext cx="9124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Suppl. Figure 2: 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Cochrane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risk-of-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bias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tool for 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randomized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trials (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RoB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2) </a:t>
            </a:r>
            <a:r>
              <a:rPr lang="en-GB" dirty="0">
                <a:solidFill>
                  <a:srgbClr val="333333"/>
                </a:solidFill>
                <a:latin typeface="Source Sans Pro" panose="020B0503030403020204" pitchFamily="34" charset="0"/>
              </a:rPr>
              <a:t>- Per Protocol studies</a:t>
            </a:r>
            <a:endParaRPr lang="en-GB" dirty="0"/>
          </a:p>
        </p:txBody>
      </p:sp>
      <p:pic>
        <p:nvPicPr>
          <p:cNvPr id="5" name="Immagine 4" descr="Immagine che contiene testo, Carattere, schermata&#10;&#10;Descrizione generata automaticamente">
            <a:extLst>
              <a:ext uri="{FF2B5EF4-FFF2-40B4-BE49-F238E27FC236}">
                <a16:creationId xmlns:a16="http://schemas.microsoft.com/office/drawing/2014/main" id="{A3545516-D228-9F8E-50BC-2EE61C08A0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0504" y="1494692"/>
            <a:ext cx="11425526" cy="2988213"/>
          </a:xfrm>
          <a:prstGeom prst="rect">
            <a:avLst/>
          </a:prstGeom>
          <a:ln w="12700">
            <a:noFill/>
          </a:ln>
        </p:spPr>
      </p:pic>
    </p:spTree>
    <p:extLst>
      <p:ext uri="{BB962C8B-B14F-4D97-AF65-F5344CB8AC3E}">
        <p14:creationId xmlns:p14="http://schemas.microsoft.com/office/powerpoint/2010/main" val="28875943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6802955C-5F74-0F6D-7C95-68B5C6170B67}"/>
              </a:ext>
            </a:extLst>
          </p:cNvPr>
          <p:cNvSpPr txBox="1"/>
          <p:nvPr/>
        </p:nvSpPr>
        <p:spPr>
          <a:xfrm>
            <a:off x="730504" y="843736"/>
            <a:ext cx="9579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Suppl. Figure 3: 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Cochrane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risk-of-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bias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tool for 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randomized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trials (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RoB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2) </a:t>
            </a:r>
            <a:r>
              <a:rPr lang="en-GB" dirty="0">
                <a:solidFill>
                  <a:srgbClr val="333333"/>
                </a:solidFill>
                <a:latin typeface="Source Sans Pro" panose="020B0503030403020204" pitchFamily="34" charset="0"/>
              </a:rPr>
              <a:t>- Intention to treat studies</a:t>
            </a:r>
            <a:endParaRPr lang="en-GB" dirty="0"/>
          </a:p>
        </p:txBody>
      </p:sp>
      <p:pic>
        <p:nvPicPr>
          <p:cNvPr id="3" name="Immagine 2" descr="Immagine che contiene testo, Carattere, linea, numero&#10;&#10;Descrizione generata automaticamente">
            <a:extLst>
              <a:ext uri="{FF2B5EF4-FFF2-40B4-BE49-F238E27FC236}">
                <a16:creationId xmlns:a16="http://schemas.microsoft.com/office/drawing/2014/main" id="{EDB57DC5-5652-ED66-F8B2-D7BBDCD4F9A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486" b="1747"/>
          <a:stretch/>
        </p:blipFill>
        <p:spPr>
          <a:xfrm>
            <a:off x="585997" y="1635369"/>
            <a:ext cx="9579867" cy="39565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19695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>
            <a:extLst>
              <a:ext uri="{FF2B5EF4-FFF2-40B4-BE49-F238E27FC236}">
                <a16:creationId xmlns:a16="http://schemas.microsoft.com/office/drawing/2014/main" id="{1F10408B-05B5-52C2-801C-04E75C5EDC75}"/>
              </a:ext>
            </a:extLst>
          </p:cNvPr>
          <p:cNvSpPr txBox="1"/>
          <p:nvPr/>
        </p:nvSpPr>
        <p:spPr>
          <a:xfrm>
            <a:off x="605978" y="1215981"/>
            <a:ext cx="9579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Suppl. Figure 4: 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Cochrane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risk-of-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bias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tool for 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randomized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trials (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RoB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2) </a:t>
            </a:r>
            <a:r>
              <a:rPr lang="en-GB" dirty="0">
                <a:solidFill>
                  <a:srgbClr val="333333"/>
                </a:solidFill>
                <a:latin typeface="Source Sans Pro" panose="020B0503030403020204" pitchFamily="34" charset="0"/>
              </a:rPr>
              <a:t>- Intention to treat studies</a:t>
            </a:r>
            <a:endParaRPr lang="en-GB" dirty="0"/>
          </a:p>
        </p:txBody>
      </p:sp>
      <p:pic>
        <p:nvPicPr>
          <p:cNvPr id="3" name="Immagine 2" descr="Immagine che contiene testo, Carattere, linea, Diagramma&#10;&#10;Descrizione generata automaticamente">
            <a:extLst>
              <a:ext uri="{FF2B5EF4-FFF2-40B4-BE49-F238E27FC236}">
                <a16:creationId xmlns:a16="http://schemas.microsoft.com/office/drawing/2014/main" id="{0A68E839-9865-8387-F838-12E94ADD10D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4858" y="2039029"/>
            <a:ext cx="11627849" cy="2740916"/>
          </a:xfrm>
          <a:prstGeom prst="rect">
            <a:avLst/>
          </a:prstGeom>
          <a:ln w="12700">
            <a:noFill/>
          </a:ln>
        </p:spPr>
      </p:pic>
    </p:spTree>
    <p:extLst>
      <p:ext uri="{BB962C8B-B14F-4D97-AF65-F5344CB8AC3E}">
        <p14:creationId xmlns:p14="http://schemas.microsoft.com/office/powerpoint/2010/main" val="37001341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E850270-A827-B64B-8C86-F61CCF3033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2365012"/>
          </a:xfrm>
        </p:spPr>
        <p:txBody>
          <a:bodyPr>
            <a:normAutofit/>
          </a:bodyPr>
          <a:lstStyle/>
          <a:p>
            <a:pPr algn="ctr"/>
            <a:r>
              <a:rPr lang="it-IT" dirty="0">
                <a:solidFill>
                  <a:srgbClr val="333333"/>
                </a:solidFill>
                <a:latin typeface="Source Sans Pro" panose="020B0503030403020204" pitchFamily="34" charset="0"/>
              </a:rPr>
              <a:t>2) Risk Of </a:t>
            </a:r>
            <a:r>
              <a:rPr lang="it-IT" dirty="0" err="1">
                <a:solidFill>
                  <a:srgbClr val="333333"/>
                </a:solidFill>
                <a:latin typeface="Source Sans Pro" panose="020B0503030403020204" pitchFamily="34" charset="0"/>
              </a:rPr>
              <a:t>Bias</a:t>
            </a:r>
            <a:r>
              <a:rPr lang="it-IT" dirty="0">
                <a:solidFill>
                  <a:srgbClr val="333333"/>
                </a:solidFill>
                <a:latin typeface="Source Sans Pro" panose="020B0503030403020204" pitchFamily="34" charset="0"/>
              </a:rPr>
              <a:t> In Non-</a:t>
            </a:r>
            <a:r>
              <a:rPr lang="it-IT" dirty="0" err="1">
                <a:solidFill>
                  <a:srgbClr val="333333"/>
                </a:solidFill>
                <a:latin typeface="Source Sans Pro" panose="020B0503030403020204" pitchFamily="34" charset="0"/>
              </a:rPr>
              <a:t>Randomized</a:t>
            </a:r>
            <a:r>
              <a:rPr lang="it-IT" dirty="0">
                <a:solidFill>
                  <a:srgbClr val="333333"/>
                </a:solidFill>
                <a:latin typeface="Source Sans Pro" panose="020B0503030403020204" pitchFamily="34" charset="0"/>
              </a:rPr>
              <a:t> Studies - of </a:t>
            </a:r>
            <a:r>
              <a:rPr lang="it-IT" dirty="0" err="1">
                <a:solidFill>
                  <a:srgbClr val="333333"/>
                </a:solidFill>
                <a:latin typeface="Source Sans Pro" panose="020B0503030403020204" pitchFamily="34" charset="0"/>
              </a:rPr>
              <a:t>Interventions</a:t>
            </a:r>
            <a:r>
              <a:rPr lang="it-IT" dirty="0">
                <a:solidFill>
                  <a:srgbClr val="333333"/>
                </a:solidFill>
                <a:latin typeface="Source Sans Pro" panose="020B0503030403020204" pitchFamily="34" charset="0"/>
              </a:rPr>
              <a:t> (ROBINS-I)</a:t>
            </a:r>
            <a:endParaRPr lang="en-GB" dirty="0">
              <a:solidFill>
                <a:srgbClr val="333333"/>
              </a:solidFill>
              <a:latin typeface="Source Sans Pro" panose="020B0503030403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57868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3C3E2577-1ABF-F73B-1E3E-0C2ACA1AC961}"/>
              </a:ext>
            </a:extLst>
          </p:cNvPr>
          <p:cNvSpPr txBox="1"/>
          <p:nvPr/>
        </p:nvSpPr>
        <p:spPr>
          <a:xfrm>
            <a:off x="605978" y="1215981"/>
            <a:ext cx="834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Suppl. Figure 5: </a:t>
            </a:r>
            <a:r>
              <a:rPr lang="it-IT" dirty="0">
                <a:solidFill>
                  <a:srgbClr val="333333"/>
                </a:solidFill>
                <a:latin typeface="Source Sans Pro" panose="020B0503030403020204" pitchFamily="34" charset="0"/>
              </a:rPr>
              <a:t>Risk Of </a:t>
            </a:r>
            <a:r>
              <a:rPr lang="it-IT" dirty="0" err="1">
                <a:solidFill>
                  <a:srgbClr val="333333"/>
                </a:solidFill>
                <a:latin typeface="Source Sans Pro" panose="020B0503030403020204" pitchFamily="34" charset="0"/>
              </a:rPr>
              <a:t>Bias</a:t>
            </a:r>
            <a:r>
              <a:rPr lang="it-IT" dirty="0">
                <a:solidFill>
                  <a:srgbClr val="333333"/>
                </a:solidFill>
                <a:latin typeface="Source Sans Pro" panose="020B0503030403020204" pitchFamily="34" charset="0"/>
              </a:rPr>
              <a:t> In Non-</a:t>
            </a:r>
            <a:r>
              <a:rPr lang="it-IT" dirty="0" err="1">
                <a:solidFill>
                  <a:srgbClr val="333333"/>
                </a:solidFill>
                <a:latin typeface="Source Sans Pro" panose="020B0503030403020204" pitchFamily="34" charset="0"/>
              </a:rPr>
              <a:t>Randomized</a:t>
            </a:r>
            <a:r>
              <a:rPr lang="it-IT" dirty="0">
                <a:solidFill>
                  <a:srgbClr val="333333"/>
                </a:solidFill>
                <a:latin typeface="Source Sans Pro" panose="020B0503030403020204" pitchFamily="34" charset="0"/>
              </a:rPr>
              <a:t> Studies - of </a:t>
            </a:r>
            <a:r>
              <a:rPr lang="it-IT" dirty="0" err="1">
                <a:solidFill>
                  <a:srgbClr val="333333"/>
                </a:solidFill>
                <a:latin typeface="Source Sans Pro" panose="020B0503030403020204" pitchFamily="34" charset="0"/>
              </a:rPr>
              <a:t>Interventions</a:t>
            </a:r>
            <a:r>
              <a:rPr lang="it-IT" dirty="0">
                <a:solidFill>
                  <a:srgbClr val="333333"/>
                </a:solidFill>
                <a:latin typeface="Source Sans Pro" panose="020B0503030403020204" pitchFamily="34" charset="0"/>
              </a:rPr>
              <a:t> (ROBINS-I)</a:t>
            </a:r>
            <a:endParaRPr lang="en-GB" dirty="0"/>
          </a:p>
        </p:txBody>
      </p:sp>
      <p:pic>
        <p:nvPicPr>
          <p:cNvPr id="8" name="Immagine 7" descr="Immagine che contiene testo, linea, diagramma, Diagramma&#10;&#10;Descrizione generata automaticamente">
            <a:extLst>
              <a:ext uri="{FF2B5EF4-FFF2-40B4-BE49-F238E27FC236}">
                <a16:creationId xmlns:a16="http://schemas.microsoft.com/office/drawing/2014/main" id="{DBCA1540-07B5-BAA0-3822-9CFD559238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9099" y="1647689"/>
            <a:ext cx="10077451" cy="35626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9904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E850270-A827-B64B-8C86-F61CCF3033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2365012"/>
          </a:xfrm>
        </p:spPr>
        <p:txBody>
          <a:bodyPr>
            <a:normAutofit/>
          </a:bodyPr>
          <a:lstStyle/>
          <a:p>
            <a:pPr algn="ctr"/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3) 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Assessment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of Risk of </a:t>
            </a:r>
            <a:r>
              <a:rPr lang="it-IT" b="0" i="0" u="none" strike="noStrike" dirty="0" err="1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Bias</a:t>
            </a:r>
            <a:r>
              <a:rPr lang="it-IT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 in Single Arm Studies </a:t>
            </a:r>
            <a:r>
              <a:rPr lang="it-IT" dirty="0">
                <a:solidFill>
                  <a:srgbClr val="333333"/>
                </a:solidFill>
                <a:latin typeface="Source Sans Pro" panose="020B0503030403020204" pitchFamily="34" charset="0"/>
              </a:rPr>
              <a:t>(</a:t>
            </a:r>
            <a:r>
              <a:rPr lang="en-US" dirty="0">
                <a:solidFill>
                  <a:srgbClr val="333333"/>
                </a:solidFill>
                <a:latin typeface="Source Sans Pro" panose="020B0503030403020204" pitchFamily="34" charset="0"/>
              </a:rPr>
              <a:t>European Association of Urology Guidelines Office</a:t>
            </a:r>
            <a:r>
              <a:rPr lang="it-IT" dirty="0">
                <a:solidFill>
                  <a:srgbClr val="333333"/>
                </a:solidFill>
                <a:latin typeface="Source Sans Pro" panose="020B0503030403020204" pitchFamily="34" charset="0"/>
              </a:rPr>
              <a:t> )</a:t>
            </a:r>
            <a:endParaRPr lang="en-GB" dirty="0">
              <a:solidFill>
                <a:srgbClr val="333333"/>
              </a:solidFill>
              <a:latin typeface="Source Sans Pro" panose="020B0503030403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117041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E95D43CF-FFAC-3A59-9C58-5E6D841BEC8F}"/>
              </a:ext>
            </a:extLst>
          </p:cNvPr>
          <p:cNvSpPr txBox="1"/>
          <p:nvPr/>
        </p:nvSpPr>
        <p:spPr>
          <a:xfrm>
            <a:off x="1246594" y="859159"/>
            <a:ext cx="4849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0" i="0" u="none" strike="noStrike" dirty="0">
                <a:solidFill>
                  <a:srgbClr val="333333"/>
                </a:solidFill>
                <a:effectLst/>
                <a:latin typeface="Source Sans Pro" panose="020B0503030403020204" pitchFamily="34" charset="0"/>
              </a:rPr>
              <a:t>Suppl. Figure 6: Risk of Bias in Single Arm Studies</a:t>
            </a:r>
            <a:endParaRPr lang="en-GB" dirty="0"/>
          </a:p>
        </p:txBody>
      </p:sp>
      <p:pic>
        <p:nvPicPr>
          <p:cNvPr id="6" name="Immagine 5" descr="Immagine che contiene testo, numero, schermata, Carattere&#10;&#10;Descrizione generata automaticamente">
            <a:extLst>
              <a:ext uri="{FF2B5EF4-FFF2-40B4-BE49-F238E27FC236}">
                <a16:creationId xmlns:a16="http://schemas.microsoft.com/office/drawing/2014/main" id="{116DB95C-5246-E370-CC66-E91260B6AF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0878" y="1629833"/>
            <a:ext cx="10470239" cy="4025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160186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182</Words>
  <Application>Microsoft Macintosh PowerPoint</Application>
  <PresentationFormat>Widescreen</PresentationFormat>
  <Paragraphs>13</Paragraphs>
  <Slides>9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9</vt:i4>
      </vt:variant>
    </vt:vector>
  </HeadingPairs>
  <TitlesOfParts>
    <vt:vector size="14" baseType="lpstr">
      <vt:lpstr>Aptos</vt:lpstr>
      <vt:lpstr>Aptos Display</vt:lpstr>
      <vt:lpstr>Arial</vt:lpstr>
      <vt:lpstr>Source Sans Pro</vt:lpstr>
      <vt:lpstr>Tema di Office</vt:lpstr>
      <vt:lpstr>1) Cochrane risk-of-bias tool for randomized trials (RoB 2)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2) Risk Of Bias In Non-Randomized Studies - of Interventions (ROBINS-I)</vt:lpstr>
      <vt:lpstr>Presentazione standard di PowerPoint</vt:lpstr>
      <vt:lpstr>3) Assessment of Risk of Bias in Single Arm Studies (European Association of Urology Guidelines Office )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1) Cochrane risk-of-bias tool for randomized trials (RoB 2)</dc:title>
  <dc:creator>MARIA GIOVANNA ROBERTA ASMUNDO</dc:creator>
  <cp:lastModifiedBy>MARIA GIOVANNA ROBERTA ASMUNDO</cp:lastModifiedBy>
  <cp:revision>6</cp:revision>
  <dcterms:created xsi:type="dcterms:W3CDTF">2024-01-22T19:48:07Z</dcterms:created>
  <dcterms:modified xsi:type="dcterms:W3CDTF">2024-01-30T16:32:47Z</dcterms:modified>
</cp:coreProperties>
</file>